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6" d="100"/>
          <a:sy n="76" d="100"/>
        </p:scale>
        <p:origin x="-1206" y="24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54380-9C01-4F7F-8967-381BBA687DEB}" type="datetimeFigureOut">
              <a:rPr lang="en-US" smtClean="0"/>
              <a:t>3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842FDA-A46F-4137-9C31-72A5AD5BAC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1716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54380-9C01-4F7F-8967-381BBA687DEB}" type="datetimeFigureOut">
              <a:rPr lang="en-US" smtClean="0"/>
              <a:t>3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842FDA-A46F-4137-9C31-72A5AD5BAC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22252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54380-9C01-4F7F-8967-381BBA687DEB}" type="datetimeFigureOut">
              <a:rPr lang="en-US" smtClean="0"/>
              <a:t>3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842FDA-A46F-4137-9C31-72A5AD5BAC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1289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54380-9C01-4F7F-8967-381BBA687DEB}" type="datetimeFigureOut">
              <a:rPr lang="en-US" smtClean="0"/>
              <a:t>3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842FDA-A46F-4137-9C31-72A5AD5BAC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2113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54380-9C01-4F7F-8967-381BBA687DEB}" type="datetimeFigureOut">
              <a:rPr lang="en-US" smtClean="0"/>
              <a:t>3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842FDA-A46F-4137-9C31-72A5AD5BAC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75195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54380-9C01-4F7F-8967-381BBA687DEB}" type="datetimeFigureOut">
              <a:rPr lang="en-US" smtClean="0"/>
              <a:t>3/1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842FDA-A46F-4137-9C31-72A5AD5BAC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20463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54380-9C01-4F7F-8967-381BBA687DEB}" type="datetimeFigureOut">
              <a:rPr lang="en-US" smtClean="0"/>
              <a:t>3/19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842FDA-A46F-4137-9C31-72A5AD5BAC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06120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54380-9C01-4F7F-8967-381BBA687DEB}" type="datetimeFigureOut">
              <a:rPr lang="en-US" smtClean="0"/>
              <a:t>3/19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842FDA-A46F-4137-9C31-72A5AD5BAC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38011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54380-9C01-4F7F-8967-381BBA687DEB}" type="datetimeFigureOut">
              <a:rPr lang="en-US" smtClean="0"/>
              <a:t>3/19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842FDA-A46F-4137-9C31-72A5AD5BAC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96900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54380-9C01-4F7F-8967-381BBA687DEB}" type="datetimeFigureOut">
              <a:rPr lang="en-US" smtClean="0"/>
              <a:t>3/1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842FDA-A46F-4137-9C31-72A5AD5BAC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97671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54380-9C01-4F7F-8967-381BBA687DEB}" type="datetimeFigureOut">
              <a:rPr lang="en-US" smtClean="0"/>
              <a:t>3/1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842FDA-A46F-4137-9C31-72A5AD5BAC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294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F54380-9C01-4F7F-8967-381BBA687DEB}" type="datetimeFigureOut">
              <a:rPr lang="en-US" smtClean="0"/>
              <a:t>3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842FDA-A46F-4137-9C31-72A5AD5BAC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53107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533400" y="5629870"/>
            <a:ext cx="80772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/>
              <a:t>S1 Figure:</a:t>
            </a:r>
            <a:r>
              <a:rPr lang="en-US" dirty="0"/>
              <a:t> Normal distribution of bacterial population </a:t>
            </a:r>
            <a:r>
              <a:rPr lang="en-US" dirty="0" smtClean="0"/>
              <a:t>isolated from </a:t>
            </a:r>
            <a:r>
              <a:rPr lang="en-US" dirty="0"/>
              <a:t>adjacent normal biopsies of colorectal cancer </a:t>
            </a:r>
            <a:r>
              <a:rPr lang="en-US" dirty="0" smtClean="0"/>
              <a:t>patients. Original bacterial population data were transformed using a natural logarithm function (</a:t>
            </a:r>
            <a:r>
              <a:rPr lang="en-US" dirty="0" err="1" smtClean="0"/>
              <a:t>ln</a:t>
            </a:r>
            <a:r>
              <a:rPr lang="en-US" dirty="0" smtClean="0"/>
              <a:t>) and Pearson r correlation test was performed using transformed data.</a:t>
            </a:r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8200" y="152400"/>
            <a:ext cx="7315200" cy="5257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713562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81000" y="5638800"/>
            <a:ext cx="82296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 smtClean="0"/>
              <a:t>S2 </a:t>
            </a:r>
            <a:r>
              <a:rPr lang="en-US" b="1" dirty="0"/>
              <a:t>Figure:</a:t>
            </a:r>
            <a:r>
              <a:rPr lang="en-US" dirty="0"/>
              <a:t> Normal distribution of bacterial population </a:t>
            </a:r>
            <a:r>
              <a:rPr lang="en-US" dirty="0" smtClean="0"/>
              <a:t>isolated from </a:t>
            </a:r>
            <a:r>
              <a:rPr lang="en-US" dirty="0"/>
              <a:t>malignant biopsies of colorectal cancer </a:t>
            </a:r>
            <a:r>
              <a:rPr lang="en-US" dirty="0" smtClean="0"/>
              <a:t>patients. Original bacterial population data were transformed using a natural logarithm function (</a:t>
            </a:r>
            <a:r>
              <a:rPr lang="en-US" dirty="0" err="1" smtClean="0"/>
              <a:t>ln</a:t>
            </a:r>
            <a:r>
              <a:rPr lang="en-US" dirty="0"/>
              <a:t>) and Pearson r correlation </a:t>
            </a:r>
            <a:r>
              <a:rPr lang="en-US" dirty="0" smtClean="0"/>
              <a:t>test was </a:t>
            </a:r>
            <a:r>
              <a:rPr lang="en-US" dirty="0"/>
              <a:t>performed using transformed data.</a:t>
            </a:r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4400" y="304800"/>
            <a:ext cx="7315200" cy="52293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7047598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7</TotalTime>
  <Words>85</Words>
  <Application>Microsoft Office PowerPoint</Application>
  <PresentationFormat>On-screen Show (4:3)</PresentationFormat>
  <Paragraphs>2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16</cp:revision>
  <dcterms:created xsi:type="dcterms:W3CDTF">2021-03-11T13:50:59Z</dcterms:created>
  <dcterms:modified xsi:type="dcterms:W3CDTF">2021-03-19T09:55:06Z</dcterms:modified>
</cp:coreProperties>
</file>